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  <p:sldId id="277" r:id="rId23"/>
    <p:sldId id="278" r:id="rId24"/>
    <p:sldId id="279" r:id="rId25"/>
    <p:sldId id="280" r:id="rId26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92" d="100"/>
          <a:sy n="92" d="100"/>
        </p:scale>
        <p:origin x="137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185600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88646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7615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6002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645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566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8167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56419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34351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2072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491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70C4CF-386C-4BB4-AC0F-1FE2C889BCBC}" type="datetimeFigureOut">
              <a:rPr kumimoji="1" lang="ja-JP" altLang="en-US" smtClean="0"/>
              <a:t>2017/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28FECC-0CD3-4BF5-9374-0B47EF9E70F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9092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jp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jp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jp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jp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jp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jp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jp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50257" y="567891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50257" y="1573731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0257" y="257957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図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67533" y="457200"/>
            <a:ext cx="6372140" cy="6151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12026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85011" y="895149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85011" y="2054994"/>
            <a:ext cx="1435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85011" y="321483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22717" y="342900"/>
            <a:ext cx="6453134" cy="62345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772481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04261" y="1039528"/>
            <a:ext cx="9108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04261" y="2141621"/>
            <a:ext cx="14264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 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04261" y="324371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79321" y="270163"/>
            <a:ext cx="6399688" cy="6213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266111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27259" y="97215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7259" y="2069432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27259" y="3166712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48354" y="218209"/>
            <a:ext cx="6590219" cy="637795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7747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08008" y="885524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1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08008" y="1876926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08008" y="286832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0246" y="270164"/>
            <a:ext cx="6464224" cy="62449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5293200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68205" y="42351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8205" y="1463041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68205" y="250256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69472" y="332508"/>
            <a:ext cx="6431627" cy="62241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84784953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62013" y="875899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2013" y="1872114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62013" y="2868328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71833" y="249382"/>
            <a:ext cx="6674220" cy="6452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891235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31006" y="760396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31006" y="1788513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1006" y="2816630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829" y="280553"/>
            <a:ext cx="6616531" cy="639040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16628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510139" y="558265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10139" y="1535230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10139" y="2512194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7663" y="360837"/>
            <a:ext cx="6487345" cy="629973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0232641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62013" y="895149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62013" y="1751798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62013" y="2608446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1282" y="280553"/>
            <a:ext cx="6553318" cy="63384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4984228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31006" y="1010653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31006" y="1910615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1006" y="2810577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7009" y="237017"/>
            <a:ext cx="6650015" cy="64547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9322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40632" y="77964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40632" y="1703672"/>
            <a:ext cx="1487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 </a:t>
            </a: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40632" y="262769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1691" y="218209"/>
            <a:ext cx="6570551" cy="63488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058219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98383" y="693019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98383" y="1737360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98383" y="278170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7536" y="172362"/>
            <a:ext cx="6721294" cy="64986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479297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42762" y="770021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42762" y="1598240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42762" y="242645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5589" y="114300"/>
            <a:ext cx="6829333" cy="65151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707736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33137" y="952901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33137" y="1896177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33137" y="2839453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99060" y="218209"/>
            <a:ext cx="6682212" cy="6483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8673734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82880" y="914400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82880" y="1833613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82880" y="2752825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7660" y="228600"/>
            <a:ext cx="6717674" cy="6483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639737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192505" y="789272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192505" y="1707591"/>
            <a:ext cx="13773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-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192505" y="2625910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8540" y="155862"/>
            <a:ext cx="6625646" cy="6431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231787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21794" y="933651"/>
            <a:ext cx="9220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</a:t>
            </a:r>
            <a:r>
              <a:rPr lang="en-US" altLang="ja-JP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21794" y="1881740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21794" y="282982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5609" y="259213"/>
            <a:ext cx="6501534" cy="62974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6077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81263" y="712269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3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81263" y="1641107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81263" y="2569945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75312" y="514842"/>
            <a:ext cx="6345914" cy="6057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4133919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211756" y="750771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4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11756" y="1698859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11756" y="2646947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6092" y="301457"/>
            <a:ext cx="6581793" cy="637989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882930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27259" y="856648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5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7259" y="2002054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27259" y="3147461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7522" y="155863"/>
            <a:ext cx="6753366" cy="65254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8986161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27259" y="114540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6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27259" y="1981018"/>
            <a:ext cx="11031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27259" y="2816630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96929" y="446809"/>
            <a:ext cx="6300955" cy="60786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6380826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522063" y="1116531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7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522063" y="2152111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522063" y="3187691"/>
            <a:ext cx="110799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6392" y="285394"/>
            <a:ext cx="6710092" cy="64790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4218806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433137" y="991402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8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433137" y="2033471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33137" y="3075539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3597" y="337989"/>
            <a:ext cx="6430409" cy="62137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06552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4"/>
          <p:cNvSpPr txBox="1"/>
          <p:nvPr/>
        </p:nvSpPr>
        <p:spPr>
          <a:xfrm>
            <a:off x="346370" y="943276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se 9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46370" y="1878167"/>
            <a:ext cx="14302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QP4 Ab (+)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346370" y="2813058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ilateral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図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18299" y="259773"/>
            <a:ext cx="6677588" cy="645275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4047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3</TotalTime>
  <Words>150</Words>
  <Application>Microsoft Office PowerPoint</Application>
  <PresentationFormat>画面に合わせる (4:3)</PresentationFormat>
  <Paragraphs>75</Paragraphs>
  <Slides>25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5</vt:i4>
      </vt:variant>
    </vt:vector>
  </HeadingPairs>
  <TitlesOfParts>
    <vt:vector size="31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中村誠</dc:creator>
  <cp:lastModifiedBy>中村誠</cp:lastModifiedBy>
  <cp:revision>25</cp:revision>
  <dcterms:created xsi:type="dcterms:W3CDTF">2016-12-18T03:23:28Z</dcterms:created>
  <dcterms:modified xsi:type="dcterms:W3CDTF">2017-02-01T12:19:45Z</dcterms:modified>
</cp:coreProperties>
</file>